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597A8-23E5-43BA-81C8-4AC0CE351F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C759E-2B88-4CED-A87E-81924F152E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F0E5C-605F-43A9-AA58-8C8CF05FB7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E4EF3-5A70-4931-9089-2C18EE5685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16D7B-A66E-4D81-9F59-97B3F525C2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0287C-D1D4-4A25-8FF3-F349D3D439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4A58C-F7CA-475C-975F-BAA2D344EE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CF1AD-6802-4B04-8699-E4B1FC5754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AF72D-E271-49C8-B29A-AFEF5A8E8C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E66C9-F703-4CB6-A6BC-712516DA9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12063-31AC-4370-8409-AF6F60639B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CC3C6-43DA-4032-BDE9-D458724542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0A53C2-C4BF-4E6B-971F-F1D8AFA4533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86040" y="24462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490680" y="223920"/>
            <a:ext cx="8272440" cy="45385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89080" y="5294160"/>
            <a:ext cx="84740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0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maps of the immediate neighborhood of the six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gr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 amoeb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esenting the two closest genes on each side of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g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and the associated intergenic spaces (pcxxxx standing for protochlamydia protein number xxxx). All maps were normalized to the transcription direction of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gr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s. The genes drawn upwards or downwards are encoded on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g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ncoding strand or its complementary strand. The narrow boxes of various sizes and colors represent different homologous regions (BLASTN: cutoff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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0.05)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19:52Z</dcterms:created>
  <dc:creator>Gilbert Greub</dc:creator>
  <dc:description/>
  <dc:language>en-US</dc:language>
  <cp:lastModifiedBy>CA Roten</cp:lastModifiedBy>
  <dcterms:modified xsi:type="dcterms:W3CDTF">2007-11-14T13:40:36Z</dcterms:modified>
  <cp:revision>7</cp:revision>
  <dc:subject/>
  <dc:title>Présentation PowerPoint</dc:title>
</cp:coreProperties>
</file>